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4" d="100"/>
          <a:sy n="64" d="100"/>
        </p:scale>
        <p:origin x="78" y="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AA0FF-CCAE-4F0F-AD85-BF2A0EDD08DC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E187-73A8-4DA9-B25F-3A3308E23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6328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AA0FF-CCAE-4F0F-AD85-BF2A0EDD08DC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E187-73A8-4DA9-B25F-3A3308E23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8256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AA0FF-CCAE-4F0F-AD85-BF2A0EDD08DC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E187-73A8-4DA9-B25F-3A3308E23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192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AA0FF-CCAE-4F0F-AD85-BF2A0EDD08DC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E187-73A8-4DA9-B25F-3A3308E23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2301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AA0FF-CCAE-4F0F-AD85-BF2A0EDD08DC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E187-73A8-4DA9-B25F-3A3308E23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5381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AA0FF-CCAE-4F0F-AD85-BF2A0EDD08DC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E187-73A8-4DA9-B25F-3A3308E23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69811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AA0FF-CCAE-4F0F-AD85-BF2A0EDD08DC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E187-73A8-4DA9-B25F-3A3308E23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1301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AA0FF-CCAE-4F0F-AD85-BF2A0EDD08DC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E187-73A8-4DA9-B25F-3A3308E23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355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AA0FF-CCAE-4F0F-AD85-BF2A0EDD08DC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E187-73A8-4DA9-B25F-3A3308E23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01080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AA0FF-CCAE-4F0F-AD85-BF2A0EDD08DC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E187-73A8-4DA9-B25F-3A3308E23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6312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AA0FF-CCAE-4F0F-AD85-BF2A0EDD08DC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C8E187-73A8-4DA9-B25F-3A3308E23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6997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DAA0FF-CCAE-4F0F-AD85-BF2A0EDD08DC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C8E187-73A8-4DA9-B25F-3A3308E235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34193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3830" y="4601916"/>
            <a:ext cx="5138222" cy="16631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3829" y="1215376"/>
            <a:ext cx="5138222" cy="16631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3831" y="6295187"/>
            <a:ext cx="5138222" cy="16631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3829" y="2908644"/>
            <a:ext cx="5138222" cy="16631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3829" y="-477895"/>
            <a:ext cx="5138222" cy="166310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="" xmlns:a16="http://schemas.microsoft.com/office/drawing/2014/main" id="{66B28FFC-3E4B-4689-B2BD-D8EBBF84FAC2}"/>
              </a:ext>
            </a:extLst>
          </p:cNvPr>
          <p:cNvSpPr txBox="1"/>
          <p:nvPr/>
        </p:nvSpPr>
        <p:spPr>
          <a:xfrm>
            <a:off x="6440677" y="-789755"/>
            <a:ext cx="1394617" cy="3554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RP1</a:t>
            </a:r>
            <a:endParaRPr kumimoji="0" lang="zh-CN" altLang="en-US" sz="1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="" xmlns:a16="http://schemas.microsoft.com/office/drawing/2014/main" id="{66B28FFC-3E4B-4689-B2BD-D8EBBF84FAC2}"/>
              </a:ext>
            </a:extLst>
          </p:cNvPr>
          <p:cNvSpPr txBox="1"/>
          <p:nvPr/>
        </p:nvSpPr>
        <p:spPr>
          <a:xfrm>
            <a:off x="8095630" y="-789755"/>
            <a:ext cx="1394617" cy="3554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kumimoji="0" lang="zh-CN" altLang="en-US" sz="1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="" xmlns:a16="http://schemas.microsoft.com/office/drawing/2014/main" id="{66B28FFC-3E4B-4689-B2BD-D8EBBF84FAC2}"/>
              </a:ext>
            </a:extLst>
          </p:cNvPr>
          <p:cNvSpPr txBox="1"/>
          <p:nvPr/>
        </p:nvSpPr>
        <p:spPr>
          <a:xfrm>
            <a:off x="9859992" y="-789755"/>
            <a:ext cx="1394617" cy="3554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kumimoji="0" lang="zh-CN" altLang="en-US" sz="1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200131" y="3425567"/>
            <a:ext cx="3023698" cy="6042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CF-7/ADR+EIF4E</a:t>
            </a:r>
          </a:p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Ad-VT</a:t>
            </a:r>
            <a:endParaRPr kumimoji="0" lang="zh-CN" altLang="en-US" sz="1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185651" y="1856706"/>
            <a:ext cx="3038178" cy="3554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CF-7/</a:t>
            </a:r>
            <a:r>
              <a:rPr kumimoji="0" lang="en-US" altLang="zh-CN" sz="1400" b="1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DR+Ad-VT</a:t>
            </a:r>
            <a:endParaRPr kumimoji="0" lang="zh-CN" altLang="en-US" sz="1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200131" y="5113656"/>
            <a:ext cx="3023698" cy="6042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CF-7/ADR+si4EBP1</a:t>
            </a:r>
          </a:p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Ad-VT</a:t>
            </a:r>
            <a:endParaRPr kumimoji="0" lang="zh-CN" altLang="en-US" sz="1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200131" y="6812106"/>
            <a:ext cx="3023698" cy="6042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CF-7/ADR+siS6K</a:t>
            </a:r>
          </a:p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Ad-VT</a:t>
            </a:r>
            <a:endParaRPr kumimoji="0" lang="zh-CN" altLang="en-US" sz="1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="" xmlns:a16="http://schemas.microsoft.com/office/drawing/2014/main" id="{66B28FFC-3E4B-4689-B2BD-D8EBBF84FAC2}"/>
              </a:ext>
            </a:extLst>
          </p:cNvPr>
          <p:cNvSpPr txBox="1"/>
          <p:nvPr/>
        </p:nvSpPr>
        <p:spPr>
          <a:xfrm>
            <a:off x="4829212" y="177885"/>
            <a:ext cx="1394617" cy="3554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CF-7/ADR</a:t>
            </a:r>
            <a:endParaRPr kumimoji="0" lang="zh-CN" altLang="en-US" sz="1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384722" y="302449"/>
            <a:ext cx="838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>
              <a:defRPr/>
            </a:pPr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5</a:t>
            </a:r>
            <a:r>
              <a:rPr kumimoji="0" lang="en-US" altLang="zh-CN" sz="20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0" lang="zh-CN" altLang="en-US" sz="2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2979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</Words>
  <Application>Microsoft Office PowerPoint</Application>
  <PresentationFormat>宽屏</PresentationFormat>
  <Paragraphs>1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905381255@qq.com</dc:creator>
  <cp:lastModifiedBy>905381255@qq.com</cp:lastModifiedBy>
  <cp:revision>1</cp:revision>
  <dcterms:created xsi:type="dcterms:W3CDTF">2021-08-25T13:45:32Z</dcterms:created>
  <dcterms:modified xsi:type="dcterms:W3CDTF">2021-08-25T13:45:42Z</dcterms:modified>
</cp:coreProperties>
</file>